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1724" r:id="rId2"/>
    <p:sldId id="188183994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6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816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de_\Desktop\&#26032;CLD&#35542;&#25991;&#20316;&#25104;&#29992;&#12486;&#12540;&#12502;&#1252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noFill/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OT at 3yrs'!$X$6:$X$13</c:f>
                <c:numCache>
                  <c:formatCode>General</c:formatCode>
                  <c:ptCount val="8"/>
                  <c:pt idx="0">
                    <c:v>6.7299999999999995</c:v>
                  </c:pt>
                  <c:pt idx="1">
                    <c:v>4.6800000000000006</c:v>
                  </c:pt>
                  <c:pt idx="2">
                    <c:v>2.8399999999999994</c:v>
                  </c:pt>
                  <c:pt idx="3">
                    <c:v>1.81</c:v>
                  </c:pt>
                  <c:pt idx="4">
                    <c:v>3.98</c:v>
                  </c:pt>
                  <c:pt idx="5">
                    <c:v>1.7899999999999998</c:v>
                  </c:pt>
                  <c:pt idx="6">
                    <c:v>1.0000000000000002</c:v>
                  </c:pt>
                  <c:pt idx="7">
                    <c:v>0</c:v>
                  </c:pt>
                </c:numCache>
              </c:numRef>
            </c:plus>
            <c:minus>
              <c:numRef>
                <c:f>'HOT at 3yrs'!$V$6:$V$13</c:f>
                <c:numCache>
                  <c:formatCode>General</c:formatCode>
                  <c:ptCount val="8"/>
                  <c:pt idx="0">
                    <c:v>2.9899999999999998</c:v>
                  </c:pt>
                  <c:pt idx="1">
                    <c:v>2.3400000000000003</c:v>
                  </c:pt>
                  <c:pt idx="2">
                    <c:v>1.6100000000000003</c:v>
                  </c:pt>
                  <c:pt idx="3">
                    <c:v>0.95999999999999974</c:v>
                  </c:pt>
                  <c:pt idx="4">
                    <c:v>1.58</c:v>
                  </c:pt>
                  <c:pt idx="5">
                    <c:v>0.83000000000000007</c:v>
                  </c:pt>
                  <c:pt idx="6">
                    <c:v>0.55999999999999994</c:v>
                  </c:pt>
                  <c:pt idx="7">
                    <c:v>0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HOT at 3yrs'!$T$6:$T$13</c:f>
              <c:numCache>
                <c:formatCode>0.00_ </c:formatCode>
                <c:ptCount val="8"/>
                <c:pt idx="0">
                  <c:v>5.39</c:v>
                </c:pt>
                <c:pt idx="1">
                  <c:v>4.7</c:v>
                </c:pt>
                <c:pt idx="2">
                  <c:v>3.72</c:v>
                </c:pt>
                <c:pt idx="3">
                  <c:v>2.0099999999999998</c:v>
                </c:pt>
                <c:pt idx="4">
                  <c:v>2.6</c:v>
                </c:pt>
                <c:pt idx="5">
                  <c:v>1.55</c:v>
                </c:pt>
                <c:pt idx="6">
                  <c:v>1.24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8A-495E-994C-ECB5EF0AB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748300544"/>
        <c:axId val="748299464"/>
      </c:barChart>
      <c:catAx>
        <c:axId val="748300544"/>
        <c:scaling>
          <c:orientation val="minMax"/>
        </c:scaling>
        <c:delete val="1"/>
        <c:axPos val="l"/>
        <c:majorTickMark val="none"/>
        <c:minorTickMark val="none"/>
        <c:tickLblPos val="nextTo"/>
        <c:crossAx val="748299464"/>
        <c:crosses val="autoZero"/>
        <c:auto val="1"/>
        <c:lblAlgn val="ctr"/>
        <c:lblOffset val="100"/>
        <c:noMultiLvlLbl val="0"/>
      </c:catAx>
      <c:valAx>
        <c:axId val="748299464"/>
        <c:scaling>
          <c:orientation val="minMax"/>
        </c:scaling>
        <c:delete val="1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0_ " sourceLinked="1"/>
        <c:majorTickMark val="none"/>
        <c:minorTickMark val="none"/>
        <c:tickLblPos val="nextTo"/>
        <c:crossAx val="7483005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C864B8-4D62-4FD9-9A97-F3BF1A5F2B24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60452D-B764-48AD-91C7-F0820E2E45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8894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B34E22-03B7-4F17-BFCA-426D660CF85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2686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980A8C-1A8F-06E6-0D01-D89243FFC5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B853023-47DB-4434-AAF8-86A5F08701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D6F156-AD45-E061-7BA9-B4A130091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7C3B81-073D-9172-E415-8C955B8E02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39F95D-B60E-EF36-FD3A-71703C401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623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CDA4B3-E03E-F29B-C4BD-B70D3F5F76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284E9DF-EC2C-019C-59A2-F02E65AFEE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5C642E-E1A9-2378-FB41-68C8E9EB5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83C11B-2805-800B-B28B-0DDFE0026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961997-2377-8EC8-DA10-6C183E9B2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798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836106F-85F8-0958-B111-9612F59113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E65B301-5B49-8F59-2FC8-C97D477DCD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5D77F9-B527-DFD8-1916-4BE15ED74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A3DFEA-3961-1565-51E3-BAA8EE0F8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48387E9-48FD-9AEB-2B5E-06E0779E7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279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A4E9CB-521F-C519-037D-C62D15E75D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07D8AD6-F623-0733-0AD3-AE920C4483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5716174-1BE9-B29E-14F3-A3436EF04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A9B288-3814-D6DF-9773-0298CBA83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FAED8A-9B0B-F38F-0F8B-41383FEEA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2790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F25FB0-0C83-6A6D-2E28-193AF6A88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32792A7-9633-5724-9E99-0999C39A16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BF7A3AF-06DF-C432-5A76-6EEB37A3EF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FF2427-174E-6B38-6716-ECE8A7255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52C59F-62E5-BCE7-D358-71F0B79F5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4702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E634FA-3CF4-97C4-BD34-8A95D2FCCD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7F2E1C-60C7-982C-D594-0AA3B5FFC2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BF17393-0F69-7B65-D442-590CF17EB4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C26846D-AB2E-96A5-8AB7-2F6805D78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F960359-F4E6-6B73-16DC-2022709A0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CDF71A5-1872-2298-01E2-624E4A84A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123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5D544F-0682-63CD-1730-585E030F1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29A169D-F92F-A133-0F74-977B93088F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D626096-1D85-D29C-DCBA-E3FD08342D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7E06A81-E396-EA6B-CEBB-ECAE47F076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A7BC817-DF58-54FA-1387-7154D32D6C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E04D8C6-3D4A-89F3-BAC3-B3D0E285D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F1E9493-B3A1-968A-65EB-053464F7F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6E29757-9497-DEBD-9129-4369E05FB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4172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30DBD9-E796-A70C-BAB9-6738436A4D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DD50972-1729-492A-F7A4-BBFA8D5564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1A47084-3FF8-C0E5-5889-382A3C304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8E4A0C4-F9A8-D09D-AB90-FE71B9114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07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1EBC138-7A99-F0C8-D51E-FD375AE24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A768467-2B10-5FD3-8BD0-5454838C8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99584FC-F0B4-E8E5-6B95-BB296672E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6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074C9C-87FA-7A9C-CFCF-2B45F16F5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7E047EC-A63D-86A1-B57F-467BAFA9F5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125E6E4-C567-FAC0-F6A8-C3D4119178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36A0AE2-FAD4-37A4-6CBF-D3B81C254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CAF1990-DD20-C001-CADC-0341C2F25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EDA4335-9A5D-44E7-8313-2F16FE839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075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876EC4-B594-6796-D6E9-DCDC262290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977C2E8-D95C-348B-1138-1EEB24A722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2317D1F-0A2B-93B3-E022-893EAA7B00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CAA8E90-98F9-A7F8-1773-D3FFE93E0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E54E26-AB36-C64B-C7C1-BAEB275E1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4AE654-636E-41C9-1144-95A47E8D4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0491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E6D8CEF-DEDB-EA40-B751-8F4B620CD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F71C0C9-F414-9663-C193-0325851EE0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1EB9BC-39F5-9F98-644A-64A8A9DAFB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51778-A847-4C1E-BA27-908BA5355CB6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F7DA5B-B8F6-1E9C-12F9-C341210981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6B5C94-AEC8-6630-4A1F-059234BA81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622A5-5B92-49BF-A046-F92DAF9FA6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9099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D0392285-5315-DF05-6DBF-4AC33EC512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4679550"/>
              </p:ext>
            </p:extLst>
          </p:nvPr>
        </p:nvGraphicFramePr>
        <p:xfrm>
          <a:off x="83702" y="83424"/>
          <a:ext cx="6300000" cy="4122741"/>
        </p:xfrm>
        <a:graphic>
          <a:graphicData uri="http://schemas.openxmlformats.org/drawingml/2006/table">
            <a:tbl>
              <a:tblPr firstRow="1">
                <a:tableStyleId>{B301B821-A1FF-4177-AEE7-76D212191A09}</a:tableStyleId>
              </a:tblPr>
              <a:tblGrid>
                <a:gridCol w="900000">
                  <a:extLst>
                    <a:ext uri="{9D8B030D-6E8A-4147-A177-3AD203B41FA5}">
                      <a16:colId xmlns:a16="http://schemas.microsoft.com/office/drawing/2014/main" val="2758646392"/>
                    </a:ext>
                  </a:extLst>
                </a:gridCol>
                <a:gridCol w="1800000">
                  <a:extLst>
                    <a:ext uri="{9D8B030D-6E8A-4147-A177-3AD203B41FA5}">
                      <a16:colId xmlns:a16="http://schemas.microsoft.com/office/drawing/2014/main" val="322473457"/>
                    </a:ext>
                  </a:extLst>
                </a:gridCol>
                <a:gridCol w="1800000">
                  <a:extLst>
                    <a:ext uri="{9D8B030D-6E8A-4147-A177-3AD203B41FA5}">
                      <a16:colId xmlns:a16="http://schemas.microsoft.com/office/drawing/2014/main" val="737367230"/>
                    </a:ext>
                  </a:extLst>
                </a:gridCol>
                <a:gridCol w="1800000">
                  <a:extLst>
                    <a:ext uri="{9D8B030D-6E8A-4147-A177-3AD203B41FA5}">
                      <a16:colId xmlns:a16="http://schemas.microsoft.com/office/drawing/2014/main" val="3069254334"/>
                    </a:ext>
                  </a:extLst>
                </a:gridCol>
              </a:tblGrid>
              <a:tr h="103315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Type</a:t>
                      </a:r>
                      <a:endParaRPr lang="en-US" sz="1600" b="0" i="0" u="none" strike="noStrike" baseline="30000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RDS</a:t>
                      </a:r>
                      <a:endParaRPr lang="en-US" altLang="ja-JP" sz="1600" b="0" u="none" strike="noStrike" baseline="30000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2300"/>
                        </a:lnSpc>
                      </a:pPr>
                      <a:r>
                        <a:rPr lang="en-US" altLang="ja-JP" sz="1600" b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Elevated IgM, CAM, or </a:t>
                      </a:r>
                      <a:r>
                        <a:rPr lang="en-US" altLang="ja-JP" sz="1600" b="0" u="none" strike="noStrike" dirty="0" err="1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funisitis</a:t>
                      </a:r>
                      <a:endParaRPr lang="en-US" altLang="ja-JP" sz="1600" b="0" u="none" strike="noStrike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2300"/>
                        </a:lnSpc>
                      </a:pPr>
                      <a:r>
                        <a:rPr lang="en-US" sz="1600" b="0" i="0" u="none" strike="noStrike" baseline="0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ubbly/cystic appearance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4771494"/>
                  </a:ext>
                </a:extLst>
              </a:tr>
              <a:tr h="44137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I</a:t>
                      </a:r>
                      <a:endParaRPr lang="en-US" altLang="ja-JP" sz="16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0832881"/>
                  </a:ext>
                </a:extLst>
              </a:tr>
              <a:tr h="44137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II</a:t>
                      </a:r>
                      <a:endParaRPr lang="en-US" altLang="ja-JP" sz="16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US" altLang="ja-JP" sz="16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1336676"/>
                  </a:ext>
                </a:extLst>
              </a:tr>
              <a:tr h="44137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III</a:t>
                      </a:r>
                      <a:endParaRPr lang="en-US" altLang="ja-JP" sz="16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9978373"/>
                  </a:ext>
                </a:extLst>
              </a:tr>
              <a:tr h="44137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cs typeface="Arial" panose="020B0604020202020204" pitchFamily="34" charset="0"/>
                        </a:rPr>
                        <a:t>IV</a:t>
                      </a:r>
                      <a:endParaRPr kumimoji="1" lang="en-US" altLang="ja-JP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4712028"/>
                  </a:ext>
                </a:extLst>
              </a:tr>
              <a:tr h="44137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II’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3106254"/>
                  </a:ext>
                </a:extLst>
              </a:tr>
              <a:tr h="44137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5277009"/>
                  </a:ext>
                </a:extLst>
              </a:tr>
              <a:tr h="44137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I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  <a:uLnTx/>
                          <a:uFillTx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10037" marR="10037" marT="100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9339185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F70C58B-A961-12DC-0B88-E8D8E3E4D43B}"/>
              </a:ext>
            </a:extLst>
          </p:cNvPr>
          <p:cNvSpPr txBox="1"/>
          <p:nvPr/>
        </p:nvSpPr>
        <p:spPr>
          <a:xfrm>
            <a:off x="83702" y="4343073"/>
            <a:ext cx="1088909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/>
              <a:t>Figure S1. Old BPD classification by the MHW research group (1992, 1996). </a:t>
            </a:r>
            <a:r>
              <a:rPr lang="en-US" altLang="ja-JP" sz="1600" dirty="0"/>
              <a:t>BPD is categorized into seven based on three criteria: RDS, intrauterine infection/inflammation, and bubbly/cystic appearance on frontal chest X-ray. The type of BPD is highlighted. RDS, respiratory distress syndrome; IgM, immunoglobulin M; CAM, chorioamnionitis; ND, no data.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3413065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A3E977D9-5AF8-00C5-34BA-45DB50D0A364}"/>
              </a:ext>
            </a:extLst>
          </p:cNvPr>
          <p:cNvGraphicFramePr>
            <a:graphicFrameLocks noGrp="1"/>
          </p:cNvGraphicFramePr>
          <p:nvPr/>
        </p:nvGraphicFramePr>
        <p:xfrm>
          <a:off x="330413" y="287761"/>
          <a:ext cx="11114107" cy="4536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4343">
                  <a:extLst>
                    <a:ext uri="{9D8B030D-6E8A-4147-A177-3AD203B41FA5}">
                      <a16:colId xmlns:a16="http://schemas.microsoft.com/office/drawing/2014/main" val="2424592085"/>
                    </a:ext>
                  </a:extLst>
                </a:gridCol>
                <a:gridCol w="984343">
                  <a:extLst>
                    <a:ext uri="{9D8B030D-6E8A-4147-A177-3AD203B41FA5}">
                      <a16:colId xmlns:a16="http://schemas.microsoft.com/office/drawing/2014/main" val="980564718"/>
                    </a:ext>
                  </a:extLst>
                </a:gridCol>
                <a:gridCol w="984343">
                  <a:extLst>
                    <a:ext uri="{9D8B030D-6E8A-4147-A177-3AD203B41FA5}">
                      <a16:colId xmlns:a16="http://schemas.microsoft.com/office/drawing/2014/main" val="134789825"/>
                    </a:ext>
                  </a:extLst>
                </a:gridCol>
                <a:gridCol w="984343">
                  <a:extLst>
                    <a:ext uri="{9D8B030D-6E8A-4147-A177-3AD203B41FA5}">
                      <a16:colId xmlns:a16="http://schemas.microsoft.com/office/drawing/2014/main" val="2209826187"/>
                    </a:ext>
                  </a:extLst>
                </a:gridCol>
                <a:gridCol w="1038984">
                  <a:extLst>
                    <a:ext uri="{9D8B030D-6E8A-4147-A177-3AD203B41FA5}">
                      <a16:colId xmlns:a16="http://schemas.microsoft.com/office/drawing/2014/main" val="1109846459"/>
                    </a:ext>
                  </a:extLst>
                </a:gridCol>
                <a:gridCol w="423754">
                  <a:extLst>
                    <a:ext uri="{9D8B030D-6E8A-4147-A177-3AD203B41FA5}">
                      <a16:colId xmlns:a16="http://schemas.microsoft.com/office/drawing/2014/main" val="4117967930"/>
                    </a:ext>
                  </a:extLst>
                </a:gridCol>
                <a:gridCol w="1683683">
                  <a:extLst>
                    <a:ext uri="{9D8B030D-6E8A-4147-A177-3AD203B41FA5}">
                      <a16:colId xmlns:a16="http://schemas.microsoft.com/office/drawing/2014/main" val="2548787659"/>
                    </a:ext>
                  </a:extLst>
                </a:gridCol>
                <a:gridCol w="4030314">
                  <a:extLst>
                    <a:ext uri="{9D8B030D-6E8A-4147-A177-3AD203B41FA5}">
                      <a16:colId xmlns:a16="http://schemas.microsoft.com/office/drawing/2014/main" val="3553263969"/>
                    </a:ext>
                  </a:extLst>
                </a:gridCol>
              </a:tblGrid>
              <a:tr h="64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ype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 err="1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CAM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G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Bubbly/</a:t>
                      </a:r>
                    </a:p>
                    <a:p>
                      <a:pPr algn="ctr" fontAlgn="ctr"/>
                      <a:r>
                        <a:rPr lang="en-US" sz="1200" b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ystic appearance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OT </a:t>
                      </a:r>
                      <a:r>
                        <a:rPr lang="en-US" sz="1100" b="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at 3 y</a:t>
                      </a:r>
                      <a:r>
                        <a:rPr lang="en-US" sz="1100" b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/o</a:t>
                      </a:r>
                    </a:p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/BPD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%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AOR* (95% CI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5688972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I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/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,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erence</a:t>
                      </a: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2937730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V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/1,177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4 (0.68-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4)</a:t>
                      </a: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156663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I(s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/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,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5 (0.72-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34)</a:t>
                      </a: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3298062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V(s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/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,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6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1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0 (1.02-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.58)</a:t>
                      </a: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868443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/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,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24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5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01 (1.05-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82)</a:t>
                      </a: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5465472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II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/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,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6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1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72 (2.11-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.56)</a:t>
                      </a: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4923605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(s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/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,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.2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70 (2.36-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.38)</a:t>
                      </a: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2376699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II(s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ja-JP" sz="1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/</a:t>
                      </a:r>
                      <a:r>
                        <a:rPr lang="en-US" altLang="ja-JP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,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8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.4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39 (2.40-12.1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1279110"/>
                  </a:ext>
                </a:extLst>
              </a:tr>
              <a:tr h="720000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0/5,368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7 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6285387"/>
                  </a:ext>
                </a:extLst>
              </a:tr>
            </a:tbl>
          </a:graphicData>
        </a:graphic>
      </p:graphicFrame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75B8DC4-DBBD-DD72-274A-AE445E1F7CDA}"/>
              </a:ext>
            </a:extLst>
          </p:cNvPr>
          <p:cNvGrpSpPr/>
          <p:nvPr/>
        </p:nvGrpSpPr>
        <p:grpSpPr>
          <a:xfrm>
            <a:off x="7422708" y="295760"/>
            <a:ext cx="4623913" cy="4369472"/>
            <a:chOff x="7440468" y="2056448"/>
            <a:chExt cx="4623913" cy="4369472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D5C132CC-DACB-D785-ADFB-8D35BCD1E230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440468" y="2561662"/>
            <a:ext cx="4522470" cy="343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87CEFC62-7945-253E-BCA3-08454DE8BE7A}"/>
                </a:ext>
              </a:extLst>
            </p:cNvPr>
            <p:cNvSpPr/>
            <p:nvPr/>
          </p:nvSpPr>
          <p:spPr>
            <a:xfrm>
              <a:off x="7761292" y="2764160"/>
              <a:ext cx="253253" cy="25325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EF0D527F-BB50-4304-A9F9-CF85D3CDDB0F}"/>
                </a:ext>
              </a:extLst>
            </p:cNvPr>
            <p:cNvSpPr/>
            <p:nvPr/>
          </p:nvSpPr>
          <p:spPr>
            <a:xfrm>
              <a:off x="7836102" y="3165660"/>
              <a:ext cx="253253" cy="25325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6053FA36-5803-FDB8-3110-551A5F9B78CC}"/>
                </a:ext>
              </a:extLst>
            </p:cNvPr>
            <p:cNvSpPr/>
            <p:nvPr/>
          </p:nvSpPr>
          <p:spPr>
            <a:xfrm>
              <a:off x="7920711" y="3562351"/>
              <a:ext cx="253253" cy="25325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A5EF2251-07D0-D994-3B4C-B4B7CE10846E}"/>
                </a:ext>
              </a:extLst>
            </p:cNvPr>
            <p:cNvSpPr/>
            <p:nvPr/>
          </p:nvSpPr>
          <p:spPr>
            <a:xfrm>
              <a:off x="8220475" y="3962814"/>
              <a:ext cx="253253" cy="25325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A9963626-E139-AA3E-543E-C35675D4E0E8}"/>
                </a:ext>
              </a:extLst>
            </p:cNvPr>
            <p:cNvSpPr/>
            <p:nvPr/>
          </p:nvSpPr>
          <p:spPr>
            <a:xfrm>
              <a:off x="8057191" y="4350232"/>
              <a:ext cx="253253" cy="25325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94F773CD-EE95-38B9-6C14-0AB47F0D2C25}"/>
                </a:ext>
              </a:extLst>
            </p:cNvPr>
            <p:cNvSpPr/>
            <p:nvPr/>
          </p:nvSpPr>
          <p:spPr>
            <a:xfrm>
              <a:off x="8538520" y="4741810"/>
              <a:ext cx="253253" cy="25325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FFAA0CFB-F2F2-58A0-9668-56423D6526EA}"/>
                </a:ext>
              </a:extLst>
            </p:cNvPr>
            <p:cNvSpPr/>
            <p:nvPr/>
          </p:nvSpPr>
          <p:spPr>
            <a:xfrm>
              <a:off x="8816140" y="5134776"/>
              <a:ext cx="253253" cy="25325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30BE8804-8FD5-0755-B544-E273ED957F45}"/>
                </a:ext>
              </a:extLst>
            </p:cNvPr>
            <p:cNvSpPr/>
            <p:nvPr/>
          </p:nvSpPr>
          <p:spPr>
            <a:xfrm>
              <a:off x="9014209" y="5530685"/>
              <a:ext cx="253253" cy="25325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ECC8F397-F3D4-8836-6BE7-B80C5C05AA4A}"/>
                </a:ext>
              </a:extLst>
            </p:cNvPr>
            <p:cNvCxnSpPr>
              <a:cxnSpLocks/>
            </p:cNvCxnSpPr>
            <p:nvPr/>
          </p:nvCxnSpPr>
          <p:spPr>
            <a:xfrm>
              <a:off x="7885118" y="2056448"/>
              <a:ext cx="0" cy="388800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F8128AE7-E345-D5C5-6EB6-913E591B7746}"/>
                </a:ext>
              </a:extLst>
            </p:cNvPr>
            <p:cNvSpPr txBox="1"/>
            <p:nvPr/>
          </p:nvSpPr>
          <p:spPr>
            <a:xfrm>
              <a:off x="7664535" y="5871642"/>
              <a:ext cx="441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1.0 </a:t>
              </a:r>
              <a:endParaRPr kumimoji="1" lang="ja-JP" altLang="en-US" sz="1200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1CA52E3D-5C22-8AF3-189D-A4343F218D10}"/>
                </a:ext>
              </a:extLst>
            </p:cNvPr>
            <p:cNvSpPr txBox="1"/>
            <p:nvPr/>
          </p:nvSpPr>
          <p:spPr>
            <a:xfrm>
              <a:off x="7968490" y="5871642"/>
              <a:ext cx="441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/>
                <a:t>2</a:t>
              </a:r>
              <a:r>
                <a:rPr kumimoji="1" lang="en-US" altLang="ja-JP" sz="1200" dirty="0"/>
                <a:t>.0 </a:t>
              </a:r>
              <a:endParaRPr kumimoji="1" lang="ja-JP" altLang="en-US" sz="1200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EF01C056-55FB-60EA-C430-21DD76169CA2}"/>
                </a:ext>
              </a:extLst>
            </p:cNvPr>
            <p:cNvSpPr txBox="1"/>
            <p:nvPr/>
          </p:nvSpPr>
          <p:spPr>
            <a:xfrm>
              <a:off x="8578466" y="5871642"/>
              <a:ext cx="441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/>
                <a:t>4</a:t>
              </a:r>
              <a:r>
                <a:rPr kumimoji="1" lang="en-US" altLang="ja-JP" sz="1200" dirty="0"/>
                <a:t>.0 </a:t>
              </a:r>
              <a:endParaRPr kumimoji="1" lang="ja-JP" altLang="en-US" sz="1200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CB8CCDDD-FB16-35E0-79B2-9F3AF591A1C0}"/>
                </a:ext>
              </a:extLst>
            </p:cNvPr>
            <p:cNvSpPr txBox="1"/>
            <p:nvPr/>
          </p:nvSpPr>
          <p:spPr>
            <a:xfrm>
              <a:off x="9175282" y="5871642"/>
              <a:ext cx="441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6.0 </a:t>
              </a:r>
              <a:endParaRPr kumimoji="1" lang="ja-JP" altLang="en-US" sz="1200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E52B80B7-22F9-7277-38C2-581F18992403}"/>
                </a:ext>
              </a:extLst>
            </p:cNvPr>
            <p:cNvSpPr txBox="1"/>
            <p:nvPr/>
          </p:nvSpPr>
          <p:spPr>
            <a:xfrm>
              <a:off x="9782475" y="5871642"/>
              <a:ext cx="441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/>
                <a:t>8</a:t>
              </a:r>
              <a:r>
                <a:rPr kumimoji="1" lang="en-US" altLang="ja-JP" sz="1200" dirty="0"/>
                <a:t>.0 </a:t>
              </a:r>
              <a:endParaRPr kumimoji="1" lang="ja-JP" altLang="en-US" sz="1200" dirty="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8B5A748A-7331-0210-E109-748DD5223A9D}"/>
                </a:ext>
              </a:extLst>
            </p:cNvPr>
            <p:cNvSpPr txBox="1"/>
            <p:nvPr/>
          </p:nvSpPr>
          <p:spPr>
            <a:xfrm>
              <a:off x="10355843" y="5871642"/>
              <a:ext cx="4852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/>
                <a:t>1</a:t>
              </a:r>
              <a:r>
                <a:rPr kumimoji="1" lang="en-US" altLang="ja-JP" sz="1200" dirty="0"/>
                <a:t>0.0 </a:t>
              </a:r>
              <a:endParaRPr kumimoji="1" lang="ja-JP" altLang="en-US" sz="1200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0AF8D7C4-CD77-380E-1E99-BD53F99FEB85}"/>
                </a:ext>
              </a:extLst>
            </p:cNvPr>
            <p:cNvSpPr txBox="1"/>
            <p:nvPr/>
          </p:nvSpPr>
          <p:spPr>
            <a:xfrm>
              <a:off x="10976998" y="5871642"/>
              <a:ext cx="4852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12.0 </a:t>
              </a:r>
              <a:endParaRPr kumimoji="1" lang="ja-JP" altLang="en-US" sz="12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ED9959E4-EDCD-E39C-35A3-DBCC057F6311}"/>
                </a:ext>
              </a:extLst>
            </p:cNvPr>
            <p:cNvSpPr txBox="1"/>
            <p:nvPr/>
          </p:nvSpPr>
          <p:spPr>
            <a:xfrm>
              <a:off x="11579098" y="5874142"/>
              <a:ext cx="4852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14.0 </a:t>
              </a:r>
              <a:endParaRPr kumimoji="1" lang="ja-JP" altLang="en-US" sz="1200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4856AB5E-F51B-30F2-6290-95AEB136C674}"/>
                </a:ext>
              </a:extLst>
            </p:cNvPr>
            <p:cNvSpPr txBox="1"/>
            <p:nvPr/>
          </p:nvSpPr>
          <p:spPr>
            <a:xfrm>
              <a:off x="9000045" y="6087366"/>
              <a:ext cx="213661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ja-JP" sz="1600" b="1" u="none" strike="noStrike" dirty="0">
                  <a:effectLst/>
                  <a:cs typeface="Times New Roman" panose="02020603050405020304" pitchFamily="18" charset="0"/>
                </a:rPr>
                <a:t>AOR (95% CI)</a:t>
              </a:r>
              <a:endParaRPr lang="en-US" altLang="ja-JP" sz="1600" b="1" i="0" u="none" strike="noStrike" dirty="0">
                <a:solidFill>
                  <a:srgbClr val="000000"/>
                </a:solidFill>
                <a:effectLst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C78D63D-DD22-B8F5-5CE7-C2314AE53BF8}"/>
              </a:ext>
            </a:extLst>
          </p:cNvPr>
          <p:cNvSpPr txBox="1"/>
          <p:nvPr/>
        </p:nvSpPr>
        <p:spPr>
          <a:xfrm>
            <a:off x="330416" y="4940064"/>
            <a:ext cx="1025185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/>
              <a:t>Figure S2. Associations of each type of BPD with HOT at 3 years of age. </a:t>
            </a:r>
            <a:r>
              <a:rPr lang="en-US" altLang="ja-JP" sz="1600" dirty="0" err="1"/>
              <a:t>hCAM</a:t>
            </a:r>
            <a:r>
              <a:rPr lang="en-US" altLang="ja-JP" sz="1600" dirty="0"/>
              <a:t>, SGA, and bubbly/cystic appearance were associated with an increase in HOT incidence at 3 years of age, particularly in combination with bubbly/cystic appearance. *, adjusted for gestational age, male sex, antenatal steroid, multiple pregnancy, Apgar score at 5 minutes &lt;4, BPD, severe intraventricular hemorrhage, periventricular leukomalacia, sepsis, and severe retinopathy of prematurity; AOR, adjusted odds ratio; BPD, bronchopulmonary dysplasia; CI, confidence interval; </a:t>
            </a:r>
            <a:r>
              <a:rPr lang="en-US" altLang="ja-JP" sz="1600" dirty="0" err="1"/>
              <a:t>hCAM</a:t>
            </a:r>
            <a:r>
              <a:rPr lang="en-US" altLang="ja-JP" sz="1600" dirty="0"/>
              <a:t>, histological chorioamnionitis; SGA, small for gestational age; HOT, home oxygen therapy; y/o, years old.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501701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2">
      <a:majorFont>
        <a:latin typeface="Segoe UI"/>
        <a:ea typeface="メイリオ"/>
        <a:cs typeface=""/>
      </a:majorFont>
      <a:minorFont>
        <a:latin typeface="Segoe UI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45</TotalTime>
  <Words>371</Words>
  <Application>Microsoft Office PowerPoint</Application>
  <PresentationFormat>ワイド画面</PresentationFormat>
  <Paragraphs>111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Segoe UI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難波 文彦</dc:creator>
  <cp:lastModifiedBy>文彦 難波</cp:lastModifiedBy>
  <cp:revision>56</cp:revision>
  <dcterms:created xsi:type="dcterms:W3CDTF">2022-12-14T13:01:00Z</dcterms:created>
  <dcterms:modified xsi:type="dcterms:W3CDTF">2025-03-27T09:52:22Z</dcterms:modified>
</cp:coreProperties>
</file>